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741"/>
  </p:normalViewPr>
  <p:slideViewPr>
    <p:cSldViewPr snapToGrid="0" snapToObjects="1">
      <p:cViewPr>
        <p:scale>
          <a:sx n="98" d="100"/>
          <a:sy n="98" d="100"/>
        </p:scale>
        <p:origin x="27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16635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28238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67160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00323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73097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4761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42402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66974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51274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90595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1725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873BB-F365-7148-B7ED-36C6C75053BE}" type="datetimeFigureOut">
              <a:rPr kumimoji="1" lang="zh-CN" altLang="en-US" smtClean="0"/>
              <a:t>2024/6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4AB281-E9B7-F044-9518-9462D2D07E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62413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png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ACBD066-1B34-9D4C-B21D-AD992668E4D9}"/>
              </a:ext>
            </a:extLst>
          </p:cNvPr>
          <p:cNvSpPr txBox="1"/>
          <p:nvPr/>
        </p:nvSpPr>
        <p:spPr>
          <a:xfrm>
            <a:off x="1531620" y="0"/>
            <a:ext cx="34290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2000" b="1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ry Material</a:t>
            </a:r>
            <a:endParaRPr lang="zh-CN" altLang="zh-CN" dirty="0">
              <a:solidFill>
                <a:srgbClr val="000000"/>
              </a:solidFill>
              <a:effectLst/>
              <a:latin typeface="Arial" panose="020B0604020202020204" pitchFamily="34" charset="0"/>
              <a:ea typeface="黑体" panose="02010609060101010101" pitchFamily="49" charset="-122"/>
              <a:cs typeface="宋体" panose="02010600030101010101" pitchFamily="2" charset="-122"/>
            </a:endParaRPr>
          </a:p>
        </p:txBody>
      </p: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9DAC753B-9FEF-954B-83ED-5D53BEA11B8C}"/>
              </a:ext>
            </a:extLst>
          </p:cNvPr>
          <p:cNvGrpSpPr/>
          <p:nvPr/>
        </p:nvGrpSpPr>
        <p:grpSpPr>
          <a:xfrm>
            <a:off x="348892" y="727850"/>
            <a:ext cx="6160215" cy="1648121"/>
            <a:chOff x="348892" y="518842"/>
            <a:chExt cx="6160215" cy="1648121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8172D81-358A-034A-B926-1E7E7F91D383}"/>
                </a:ext>
              </a:extLst>
            </p:cNvPr>
            <p:cNvSpPr txBox="1"/>
            <p:nvPr/>
          </p:nvSpPr>
          <p:spPr>
            <a:xfrm>
              <a:off x="1416943" y="1859186"/>
              <a:ext cx="436626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effectLst/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Full western blot images related to Figure 6C</a:t>
              </a:r>
              <a:r>
                <a:rPr lang="zh-CN" altLang="zh-CN" sz="14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FBCFF938-9738-F840-9390-52615C48AAD8}"/>
                </a:ext>
              </a:extLst>
            </p:cNvPr>
            <p:cNvGrpSpPr/>
            <p:nvPr/>
          </p:nvGrpSpPr>
          <p:grpSpPr>
            <a:xfrm>
              <a:off x="348892" y="518842"/>
              <a:ext cx="6160215" cy="1387474"/>
              <a:chOff x="238724" y="739102"/>
              <a:chExt cx="6160215" cy="1387474"/>
            </a:xfrm>
          </p:grpSpPr>
          <p:grpSp>
            <p:nvGrpSpPr>
              <p:cNvPr id="24" name="组合 23">
                <a:extLst>
                  <a:ext uri="{FF2B5EF4-FFF2-40B4-BE49-F238E27FC236}">
                    <a16:creationId xmlns:a16="http://schemas.microsoft.com/office/drawing/2014/main" id="{E70B7088-BDAD-FB40-8A97-F3B74C5556FB}"/>
                  </a:ext>
                </a:extLst>
              </p:cNvPr>
              <p:cNvGrpSpPr/>
              <p:nvPr/>
            </p:nvGrpSpPr>
            <p:grpSpPr>
              <a:xfrm>
                <a:off x="5334799" y="739102"/>
                <a:ext cx="1064140" cy="1268147"/>
                <a:chOff x="5720006" y="1027867"/>
                <a:chExt cx="1825027" cy="2009010"/>
              </a:xfrm>
            </p:grpSpPr>
            <p:pic>
              <p:nvPicPr>
                <p:cNvPr id="8" name="图片 7">
                  <a:extLst>
                    <a:ext uri="{FF2B5EF4-FFF2-40B4-BE49-F238E27FC236}">
                      <a16:creationId xmlns:a16="http://schemas.microsoft.com/office/drawing/2014/main" id="{A018CD0F-72E5-504D-A474-10CD439B02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4675" t="16300" r="25269" b="15239"/>
                <a:stretch/>
              </p:blipFill>
              <p:spPr>
                <a:xfrm>
                  <a:off x="5720006" y="1027867"/>
                  <a:ext cx="1825027" cy="2009010"/>
                </a:xfrm>
                <a:prstGeom prst="rect">
                  <a:avLst/>
                </a:prstGeom>
              </p:spPr>
            </p:pic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C3D2625F-939D-4646-9FAE-78FE4DCC41BE}"/>
                    </a:ext>
                  </a:extLst>
                </p:cNvPr>
                <p:cNvSpPr txBox="1"/>
                <p:nvPr/>
              </p:nvSpPr>
              <p:spPr>
                <a:xfrm rot="21138609">
                  <a:off x="5854686" y="1650739"/>
                  <a:ext cx="1416288" cy="307777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kumimoji="1" lang="zh-CN" altLang="en-US" sz="1400" dirty="0"/>
                </a:p>
              </p:txBody>
            </p:sp>
          </p:grp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C8EB3480-5214-B94B-82D0-33935A6EE062}"/>
                  </a:ext>
                </a:extLst>
              </p:cNvPr>
              <p:cNvSpPr txBox="1"/>
              <p:nvPr/>
            </p:nvSpPr>
            <p:spPr>
              <a:xfrm>
                <a:off x="5477420" y="764488"/>
                <a:ext cx="69762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RIP3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5" name="组合 14">
                <a:extLst>
                  <a:ext uri="{FF2B5EF4-FFF2-40B4-BE49-F238E27FC236}">
                    <a16:creationId xmlns:a16="http://schemas.microsoft.com/office/drawing/2014/main" id="{5E17F134-3758-C54D-AFEA-FBB651F3EAEC}"/>
                  </a:ext>
                </a:extLst>
              </p:cNvPr>
              <p:cNvGrpSpPr/>
              <p:nvPr/>
            </p:nvGrpSpPr>
            <p:grpSpPr>
              <a:xfrm>
                <a:off x="3323193" y="915314"/>
                <a:ext cx="1658395" cy="1002191"/>
                <a:chOff x="3033633" y="915314"/>
                <a:chExt cx="1658395" cy="1002191"/>
              </a:xfrm>
            </p:grpSpPr>
            <p:pic>
              <p:nvPicPr>
                <p:cNvPr id="12" name="图片 11">
                  <a:extLst>
                    <a:ext uri="{FF2B5EF4-FFF2-40B4-BE49-F238E27FC236}">
                      <a16:creationId xmlns:a16="http://schemas.microsoft.com/office/drawing/2014/main" id="{739D151C-6BB0-464C-B170-E72D373AB1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24430" t="50000" r="27897" b="15453"/>
                <a:stretch/>
              </p:blipFill>
              <p:spPr>
                <a:xfrm>
                  <a:off x="3033633" y="950235"/>
                  <a:ext cx="1658395" cy="967270"/>
                </a:xfrm>
                <a:prstGeom prst="rect">
                  <a:avLst/>
                </a:prstGeom>
              </p:spPr>
            </p:pic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247EAC8A-DE07-5A43-90FC-DD3E5522BA66}"/>
                    </a:ext>
                  </a:extLst>
                </p:cNvPr>
                <p:cNvSpPr txBox="1"/>
                <p:nvPr/>
              </p:nvSpPr>
              <p:spPr>
                <a:xfrm>
                  <a:off x="3552592" y="915314"/>
                  <a:ext cx="60625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FP</a:t>
                  </a:r>
                  <a:endParaRPr kumimoji="1" lang="zh-CN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112DFBF6-77EE-B643-A9D1-5D6B741BD5C1}"/>
                    </a:ext>
                  </a:extLst>
                </p:cNvPr>
                <p:cNvSpPr txBox="1"/>
                <p:nvPr/>
              </p:nvSpPr>
              <p:spPr>
                <a:xfrm>
                  <a:off x="3185160" y="1218947"/>
                  <a:ext cx="1341120" cy="472440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kumimoji="1" lang="zh-CN" altLang="en-US" dirty="0"/>
                </a:p>
              </p:txBody>
            </p:sp>
          </p:grp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749A2472-C3DC-2345-B8EE-86068F81D6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2191" t="19743" r="21615" b="12656"/>
              <a:stretch/>
            </p:blipFill>
            <p:spPr>
              <a:xfrm>
                <a:off x="1791312" y="783757"/>
                <a:ext cx="1386839" cy="1342819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A8ADE17A-A6FA-D144-A9AB-058EFB7CC5CA}"/>
                  </a:ext>
                </a:extLst>
              </p:cNvPr>
              <p:cNvSpPr txBox="1"/>
              <p:nvPr/>
            </p:nvSpPr>
            <p:spPr>
              <a:xfrm>
                <a:off x="1896434" y="1234291"/>
                <a:ext cx="980327" cy="27699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kumimoji="1" lang="zh-CN" altLang="en-US" sz="1200" dirty="0"/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7B3B3E5E-1D82-1348-9CE0-1EB179C1ABA6}"/>
                  </a:ext>
                </a:extLst>
              </p:cNvPr>
              <p:cNvSpPr txBox="1"/>
              <p:nvPr/>
            </p:nvSpPr>
            <p:spPr>
              <a:xfrm>
                <a:off x="2078083" y="781723"/>
                <a:ext cx="69762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RIP3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组合 22">
                <a:extLst>
                  <a:ext uri="{FF2B5EF4-FFF2-40B4-BE49-F238E27FC236}">
                    <a16:creationId xmlns:a16="http://schemas.microsoft.com/office/drawing/2014/main" id="{3CF3707F-8A71-4D45-9CF9-5930C5610697}"/>
                  </a:ext>
                </a:extLst>
              </p:cNvPr>
              <p:cNvGrpSpPr/>
              <p:nvPr/>
            </p:nvGrpSpPr>
            <p:grpSpPr>
              <a:xfrm>
                <a:off x="238724" y="966389"/>
                <a:ext cx="1386840" cy="1131538"/>
                <a:chOff x="746761" y="2026920"/>
                <a:chExt cx="1676805" cy="1600200"/>
              </a:xfrm>
            </p:grpSpPr>
            <p:pic>
              <p:nvPicPr>
                <p:cNvPr id="19" name="图片 18">
                  <a:extLst>
                    <a:ext uri="{FF2B5EF4-FFF2-40B4-BE49-F238E27FC236}">
                      <a16:creationId xmlns:a16="http://schemas.microsoft.com/office/drawing/2014/main" id="{987FF28B-6E1F-F64F-9BF4-52808D75614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18392" t="17417" r="24674" b="15080"/>
                <a:stretch/>
              </p:blipFill>
              <p:spPr>
                <a:xfrm>
                  <a:off x="746761" y="2026920"/>
                  <a:ext cx="1676805" cy="1600200"/>
                </a:xfrm>
                <a:prstGeom prst="rect">
                  <a:avLst/>
                </a:prstGeom>
              </p:spPr>
            </p:pic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D11E511C-3B97-1D40-B7B5-E4CC3D2EA2D4}"/>
                    </a:ext>
                  </a:extLst>
                </p:cNvPr>
                <p:cNvSpPr txBox="1"/>
                <p:nvPr/>
              </p:nvSpPr>
              <p:spPr>
                <a:xfrm rot="21419724">
                  <a:off x="909334" y="2409302"/>
                  <a:ext cx="1123699" cy="261610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kumimoji="1" lang="zh-CN" altLang="en-US" sz="1050" dirty="0"/>
                </a:p>
              </p:txBody>
            </p:sp>
          </p:grp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0BE2EF85-428E-F84C-9D7A-6025E654CE06}"/>
                  </a:ext>
                </a:extLst>
              </p:cNvPr>
              <p:cNvSpPr txBox="1"/>
              <p:nvPr/>
            </p:nvSpPr>
            <p:spPr>
              <a:xfrm>
                <a:off x="521055" y="924137"/>
                <a:ext cx="6062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  <a:endParaRPr kumimoji="1"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917B4298-CA2F-4240-B16F-3E56D6A20915}"/>
              </a:ext>
            </a:extLst>
          </p:cNvPr>
          <p:cNvGrpSpPr/>
          <p:nvPr/>
        </p:nvGrpSpPr>
        <p:grpSpPr>
          <a:xfrm>
            <a:off x="1226404" y="2822795"/>
            <a:ext cx="4817258" cy="2876126"/>
            <a:chOff x="1226404" y="2940362"/>
            <a:chExt cx="4817258" cy="2876126"/>
          </a:xfrm>
        </p:grpSpPr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7765DD9B-6961-A54B-A30D-F847F5BA5014}"/>
                </a:ext>
              </a:extLst>
            </p:cNvPr>
            <p:cNvSpPr txBox="1"/>
            <p:nvPr/>
          </p:nvSpPr>
          <p:spPr>
            <a:xfrm>
              <a:off x="1416943" y="5508711"/>
              <a:ext cx="436626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effectLst/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Full western blot images related to Figure 6D</a:t>
              </a:r>
              <a:r>
                <a:rPr lang="zh-CN" altLang="zh-CN" sz="14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01EEA495-9645-E545-8E68-1620A89FD3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1943" t="22912" r="21760" b="13726"/>
            <a:stretch/>
          </p:blipFill>
          <p:spPr>
            <a:xfrm>
              <a:off x="1232322" y="3135255"/>
              <a:ext cx="1275487" cy="981144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8321D68F-F0E5-F641-8520-87BE16AC16DC}"/>
                </a:ext>
              </a:extLst>
            </p:cNvPr>
            <p:cNvSpPr txBox="1"/>
            <p:nvPr/>
          </p:nvSpPr>
          <p:spPr>
            <a:xfrm rot="21433883">
              <a:off x="1325030" y="3367108"/>
              <a:ext cx="1067487" cy="18466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sz="6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D9CC19E-6B43-B74F-B7E7-0691DF217601}"/>
                </a:ext>
              </a:extLst>
            </p:cNvPr>
            <p:cNvSpPr txBox="1"/>
            <p:nvPr/>
          </p:nvSpPr>
          <p:spPr>
            <a:xfrm>
              <a:off x="1512031" y="3071015"/>
              <a:ext cx="6062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7AF8DC2D-614C-0C43-911B-FB79D3097C2A}"/>
                </a:ext>
              </a:extLst>
            </p:cNvPr>
            <p:cNvGrpSpPr/>
            <p:nvPr/>
          </p:nvGrpSpPr>
          <p:grpSpPr>
            <a:xfrm>
              <a:off x="2910990" y="2940362"/>
              <a:ext cx="1275487" cy="1052222"/>
              <a:chOff x="2743625" y="2715889"/>
              <a:chExt cx="1275487" cy="1052222"/>
            </a:xfrm>
          </p:grpSpPr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60D2AA11-C7F0-3640-AB19-4DFDAA5E788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3577" t="5305" r="19462" b="21930"/>
              <a:stretch/>
            </p:blipFill>
            <p:spPr>
              <a:xfrm>
                <a:off x="2743625" y="2979391"/>
                <a:ext cx="1275487" cy="788720"/>
              </a:xfrm>
              <a:prstGeom prst="rect">
                <a:avLst/>
              </a:prstGeom>
            </p:spPr>
          </p:pic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58702FB3-AF32-B443-AC81-299E26D502E7}"/>
                  </a:ext>
                </a:extLst>
              </p:cNvPr>
              <p:cNvSpPr txBox="1"/>
              <p:nvPr/>
            </p:nvSpPr>
            <p:spPr>
              <a:xfrm>
                <a:off x="2891794" y="3153067"/>
                <a:ext cx="1067487" cy="18466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kumimoji="1" lang="zh-CN" altLang="en-US" sz="600" dirty="0"/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D8D4BC7B-AF99-E84E-8AA0-7BA46005F20F}"/>
                  </a:ext>
                </a:extLst>
              </p:cNvPr>
              <p:cNvSpPr txBox="1"/>
              <p:nvPr/>
            </p:nvSpPr>
            <p:spPr>
              <a:xfrm>
                <a:off x="3078240" y="2715889"/>
                <a:ext cx="63991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RIP3</a:t>
                </a:r>
                <a:endParaRPr kumimoji="1"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DBFB00FD-B03A-DD49-B502-2ED297D57B37}"/>
                </a:ext>
              </a:extLst>
            </p:cNvPr>
            <p:cNvGrpSpPr/>
            <p:nvPr/>
          </p:nvGrpSpPr>
          <p:grpSpPr>
            <a:xfrm>
              <a:off x="2910990" y="4210134"/>
              <a:ext cx="1296424" cy="1265646"/>
              <a:chOff x="3429000" y="3441366"/>
              <a:chExt cx="1296424" cy="1265646"/>
            </a:xfrm>
          </p:grpSpPr>
          <p:grpSp>
            <p:nvGrpSpPr>
              <p:cNvPr id="38" name="组合 37">
                <a:extLst>
                  <a:ext uri="{FF2B5EF4-FFF2-40B4-BE49-F238E27FC236}">
                    <a16:creationId xmlns:a16="http://schemas.microsoft.com/office/drawing/2014/main" id="{9F963B20-707A-F543-A8CA-C35A09B86F3C}"/>
                  </a:ext>
                </a:extLst>
              </p:cNvPr>
              <p:cNvGrpSpPr/>
              <p:nvPr/>
            </p:nvGrpSpPr>
            <p:grpSpPr>
              <a:xfrm>
                <a:off x="3429000" y="3441366"/>
                <a:ext cx="1296424" cy="1265646"/>
                <a:chOff x="3635595" y="3441365"/>
                <a:chExt cx="1593993" cy="1329051"/>
              </a:xfrm>
            </p:grpSpPr>
            <p:pic>
              <p:nvPicPr>
                <p:cNvPr id="35" name="图片 34">
                  <a:extLst>
                    <a:ext uri="{FF2B5EF4-FFF2-40B4-BE49-F238E27FC236}">
                      <a16:creationId xmlns:a16="http://schemas.microsoft.com/office/drawing/2014/main" id="{F4C41B8C-703C-8941-8B96-87226491EB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14489" t="17626" r="18542" b="13000"/>
                <a:stretch/>
              </p:blipFill>
              <p:spPr>
                <a:xfrm>
                  <a:off x="3635595" y="3441365"/>
                  <a:ext cx="1593993" cy="1329051"/>
                </a:xfrm>
                <a:prstGeom prst="rect">
                  <a:avLst/>
                </a:prstGeom>
              </p:spPr>
            </p:pic>
            <p:sp>
              <p:nvSpPr>
                <p:cNvPr id="36" name="文本框 35">
                  <a:extLst>
                    <a:ext uri="{FF2B5EF4-FFF2-40B4-BE49-F238E27FC236}">
                      <a16:creationId xmlns:a16="http://schemas.microsoft.com/office/drawing/2014/main" id="{B8BC9C47-81F2-5740-8A52-07FC2FB62A4C}"/>
                    </a:ext>
                  </a:extLst>
                </p:cNvPr>
                <p:cNvSpPr txBox="1"/>
                <p:nvPr/>
              </p:nvSpPr>
              <p:spPr>
                <a:xfrm rot="21418826">
                  <a:off x="3756396" y="3976419"/>
                  <a:ext cx="1336372" cy="184666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kumimoji="1" lang="zh-CN" altLang="en-US" sz="600" dirty="0"/>
                </a:p>
              </p:txBody>
            </p:sp>
          </p:grp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EFDB613D-3F76-DE41-9143-B51434584438}"/>
                  </a:ext>
                </a:extLst>
              </p:cNvPr>
              <p:cNvSpPr txBox="1"/>
              <p:nvPr/>
            </p:nvSpPr>
            <p:spPr>
              <a:xfrm>
                <a:off x="3619292" y="3553736"/>
                <a:ext cx="90281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p-MLKL</a:t>
                </a:r>
                <a:endParaRPr kumimoji="1"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96B27611-F5F8-4443-8DAF-6C13C963E26F}"/>
                </a:ext>
              </a:extLst>
            </p:cNvPr>
            <p:cNvGrpSpPr/>
            <p:nvPr/>
          </p:nvGrpSpPr>
          <p:grpSpPr>
            <a:xfrm>
              <a:off x="4582787" y="4186985"/>
              <a:ext cx="1460875" cy="1205485"/>
              <a:chOff x="3641513" y="4220642"/>
              <a:chExt cx="1460875" cy="1205485"/>
            </a:xfrm>
          </p:grpSpPr>
          <p:grpSp>
            <p:nvGrpSpPr>
              <p:cNvPr id="44" name="组合 43">
                <a:extLst>
                  <a:ext uri="{FF2B5EF4-FFF2-40B4-BE49-F238E27FC236}">
                    <a16:creationId xmlns:a16="http://schemas.microsoft.com/office/drawing/2014/main" id="{0B8B6C94-D5D8-6D43-BB6C-44A6E6A35942}"/>
                  </a:ext>
                </a:extLst>
              </p:cNvPr>
              <p:cNvGrpSpPr/>
              <p:nvPr/>
            </p:nvGrpSpPr>
            <p:grpSpPr>
              <a:xfrm>
                <a:off x="3641513" y="4220642"/>
                <a:ext cx="1460875" cy="1205485"/>
                <a:chOff x="3787781" y="3470763"/>
                <a:chExt cx="2128388" cy="1741317"/>
              </a:xfrm>
            </p:grpSpPr>
            <p:pic>
              <p:nvPicPr>
                <p:cNvPr id="41" name="图片 40">
                  <a:extLst>
                    <a:ext uri="{FF2B5EF4-FFF2-40B4-BE49-F238E27FC236}">
                      <a16:creationId xmlns:a16="http://schemas.microsoft.com/office/drawing/2014/main" id="{F6DB4094-9ADF-2D4E-9A2B-EA83A5FAA72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16740" t="21139" r="17041" b="11551"/>
                <a:stretch/>
              </p:blipFill>
              <p:spPr>
                <a:xfrm>
                  <a:off x="3787781" y="3470763"/>
                  <a:ext cx="2128388" cy="1741317"/>
                </a:xfrm>
                <a:prstGeom prst="rect">
                  <a:avLst/>
                </a:prstGeom>
              </p:spPr>
            </p:pic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7311B2E2-C3EE-B84A-B36C-4AABA356053A}"/>
                    </a:ext>
                  </a:extLst>
                </p:cNvPr>
                <p:cNvSpPr txBox="1"/>
                <p:nvPr/>
              </p:nvSpPr>
              <p:spPr>
                <a:xfrm>
                  <a:off x="3919621" y="4294220"/>
                  <a:ext cx="1854438" cy="250347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endParaRPr kumimoji="1" lang="zh-CN" altLang="en-US" sz="600" dirty="0"/>
                </a:p>
              </p:txBody>
            </p:sp>
          </p:grp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46D35582-B763-AE48-BA9D-008E08E7EBA2}"/>
                  </a:ext>
                </a:extLst>
              </p:cNvPr>
              <p:cNvSpPr txBox="1"/>
              <p:nvPr/>
            </p:nvSpPr>
            <p:spPr>
              <a:xfrm>
                <a:off x="4048466" y="4362296"/>
                <a:ext cx="63991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kumimoji="1"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1B5F6F2D-93EB-6F4B-9D28-DE284E809C88}"/>
                </a:ext>
              </a:extLst>
            </p:cNvPr>
            <p:cNvGrpSpPr/>
            <p:nvPr/>
          </p:nvGrpSpPr>
          <p:grpSpPr>
            <a:xfrm>
              <a:off x="1226404" y="4270294"/>
              <a:ext cx="1460875" cy="1205486"/>
              <a:chOff x="2935224" y="5053877"/>
              <a:chExt cx="2942352" cy="2224747"/>
            </a:xfrm>
          </p:grpSpPr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7B883933-D867-4048-B584-40CCB509A1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23844" t="14120" r="8806" b="22410"/>
              <a:stretch/>
            </p:blipFill>
            <p:spPr>
              <a:xfrm>
                <a:off x="2935224" y="5053877"/>
                <a:ext cx="2942352" cy="2224747"/>
              </a:xfrm>
              <a:prstGeom prst="rect">
                <a:avLst/>
              </a:prstGeom>
            </p:spPr>
          </p:pic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4F360AAB-D81D-ED4D-9F9D-08A8BC889E25}"/>
                  </a:ext>
                </a:extLst>
              </p:cNvPr>
              <p:cNvSpPr txBox="1"/>
              <p:nvPr/>
            </p:nvSpPr>
            <p:spPr>
              <a:xfrm>
                <a:off x="3088921" y="5952600"/>
                <a:ext cx="2571216" cy="23083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kumimoji="1" lang="zh-CN" altLang="en-US" sz="900" dirty="0"/>
              </a:p>
            </p:txBody>
          </p:sp>
        </p:grp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6DAAF44C-7E85-0443-90FD-E447CEFDC332}"/>
                </a:ext>
              </a:extLst>
            </p:cNvPr>
            <p:cNvSpPr txBox="1"/>
            <p:nvPr/>
          </p:nvSpPr>
          <p:spPr>
            <a:xfrm>
              <a:off x="1519199" y="4321234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MLKL</a:t>
              </a:r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7" name="组合 56">
              <a:extLst>
                <a:ext uri="{FF2B5EF4-FFF2-40B4-BE49-F238E27FC236}">
                  <a16:creationId xmlns:a16="http://schemas.microsoft.com/office/drawing/2014/main" id="{A81FFD5C-11E9-6B44-A728-33204E6211BF}"/>
                </a:ext>
              </a:extLst>
            </p:cNvPr>
            <p:cNvGrpSpPr/>
            <p:nvPr/>
          </p:nvGrpSpPr>
          <p:grpSpPr>
            <a:xfrm>
              <a:off x="4582787" y="2978329"/>
              <a:ext cx="1460875" cy="1173661"/>
              <a:chOff x="-1436042" y="5868743"/>
              <a:chExt cx="4347032" cy="3320452"/>
            </a:xfrm>
          </p:grpSpPr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AEC227D2-436B-0445-8A12-38AF5A74A5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16930" t="21193" r="16372" b="15510"/>
              <a:stretch/>
            </p:blipFill>
            <p:spPr>
              <a:xfrm>
                <a:off x="-1436042" y="5868743"/>
                <a:ext cx="4347032" cy="3320452"/>
              </a:xfrm>
              <a:prstGeom prst="rect">
                <a:avLst/>
              </a:prstGeom>
            </p:spPr>
          </p:pic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53BB17E7-7709-1F44-9929-1000A800D947}"/>
                  </a:ext>
                </a:extLst>
              </p:cNvPr>
              <p:cNvSpPr txBox="1"/>
              <p:nvPr/>
            </p:nvSpPr>
            <p:spPr>
              <a:xfrm rot="150789">
                <a:off x="-1026482" y="7235766"/>
                <a:ext cx="3605801" cy="36933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kumimoji="1" lang="zh-CN" altLang="en-US" dirty="0"/>
              </a:p>
            </p:txBody>
          </p:sp>
        </p:grp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D061339A-2AC6-AB44-BA28-BAAAFFEFCE29}"/>
                </a:ext>
              </a:extLst>
            </p:cNvPr>
            <p:cNvSpPr txBox="1"/>
            <p:nvPr/>
          </p:nvSpPr>
          <p:spPr>
            <a:xfrm>
              <a:off x="4859374" y="3158462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-RIP3</a:t>
              </a:r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24AC10A3-B602-064F-B119-E4A6B728ED13}"/>
              </a:ext>
            </a:extLst>
          </p:cNvPr>
          <p:cNvGrpSpPr/>
          <p:nvPr/>
        </p:nvGrpSpPr>
        <p:grpSpPr>
          <a:xfrm>
            <a:off x="915410" y="6307033"/>
            <a:ext cx="1399585" cy="1290571"/>
            <a:chOff x="-705394" y="6430295"/>
            <a:chExt cx="5288181" cy="3719546"/>
          </a:xfrm>
        </p:grpSpPr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id="{17F77517-E17E-3043-A0A4-210911CE4A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4625" t="19524" r="14687" b="18703"/>
            <a:stretch/>
          </p:blipFill>
          <p:spPr>
            <a:xfrm>
              <a:off x="-705394" y="6430295"/>
              <a:ext cx="5288181" cy="3719546"/>
            </a:xfrm>
            <a:prstGeom prst="rect">
              <a:avLst/>
            </a:prstGeom>
          </p:spPr>
        </p:pic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EB39D9BB-50DD-AC4C-A100-4D173E2395D2}"/>
                </a:ext>
              </a:extLst>
            </p:cNvPr>
            <p:cNvSpPr txBox="1"/>
            <p:nvPr/>
          </p:nvSpPr>
          <p:spPr>
            <a:xfrm>
              <a:off x="-404948" y="7333974"/>
              <a:ext cx="4290472" cy="40011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sz="2000" dirty="0"/>
            </a:p>
          </p:txBody>
        </p: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AB126636-2164-3447-83E0-C429E28447CF}"/>
              </a:ext>
            </a:extLst>
          </p:cNvPr>
          <p:cNvGrpSpPr/>
          <p:nvPr/>
        </p:nvGrpSpPr>
        <p:grpSpPr>
          <a:xfrm>
            <a:off x="2531760" y="6307033"/>
            <a:ext cx="1964316" cy="1290571"/>
            <a:chOff x="3540034" y="6594457"/>
            <a:chExt cx="3056709" cy="2119637"/>
          </a:xfrm>
        </p:grpSpPr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id="{1BA1EA2F-546F-AB45-B55D-DB1579D70F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4291" t="20499" r="18931" b="21969"/>
            <a:stretch/>
          </p:blipFill>
          <p:spPr>
            <a:xfrm>
              <a:off x="3540034" y="6594457"/>
              <a:ext cx="3056709" cy="2119637"/>
            </a:xfrm>
            <a:prstGeom prst="rect">
              <a:avLst/>
            </a:prstGeom>
          </p:spPr>
        </p:pic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CE88920F-FDAD-4D4A-ADFB-6F1DFB3F63B8}"/>
                </a:ext>
              </a:extLst>
            </p:cNvPr>
            <p:cNvSpPr txBox="1"/>
            <p:nvPr/>
          </p:nvSpPr>
          <p:spPr>
            <a:xfrm>
              <a:off x="3749041" y="7281472"/>
              <a:ext cx="2609552" cy="338554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sz="1600" dirty="0"/>
            </a:p>
          </p:txBody>
        </p:sp>
      </p:grpSp>
      <p:sp>
        <p:nvSpPr>
          <p:cNvPr id="71" name="文本框 70">
            <a:extLst>
              <a:ext uri="{FF2B5EF4-FFF2-40B4-BE49-F238E27FC236}">
                <a16:creationId xmlns:a16="http://schemas.microsoft.com/office/drawing/2014/main" id="{E0035911-AB20-2743-8EE2-FEB42C0D74CD}"/>
              </a:ext>
            </a:extLst>
          </p:cNvPr>
          <p:cNvSpPr txBox="1"/>
          <p:nvPr/>
        </p:nvSpPr>
        <p:spPr>
          <a:xfrm>
            <a:off x="1329455" y="6294531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36BBEAEE-7C80-1349-BE7B-E8632C798FC3}"/>
              </a:ext>
            </a:extLst>
          </p:cNvPr>
          <p:cNvSpPr txBox="1"/>
          <p:nvPr/>
        </p:nvSpPr>
        <p:spPr>
          <a:xfrm>
            <a:off x="3101282" y="6346403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IP3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29B2E393-264D-AD43-9BC4-6D8AFB2617CE}"/>
              </a:ext>
            </a:extLst>
          </p:cNvPr>
          <p:cNvGrpSpPr/>
          <p:nvPr/>
        </p:nvGrpSpPr>
        <p:grpSpPr>
          <a:xfrm>
            <a:off x="4712841" y="6131641"/>
            <a:ext cx="1796266" cy="1494429"/>
            <a:chOff x="1531620" y="3335025"/>
            <a:chExt cx="5770517" cy="4450438"/>
          </a:xfrm>
        </p:grpSpPr>
        <p:pic>
          <p:nvPicPr>
            <p:cNvPr id="73" name="图片 72">
              <a:extLst>
                <a:ext uri="{FF2B5EF4-FFF2-40B4-BE49-F238E27FC236}">
                  <a16:creationId xmlns:a16="http://schemas.microsoft.com/office/drawing/2014/main" id="{6D09D42F-C2A7-0348-9CB4-D434B33297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2564" t="10934" r="18546" b="23056"/>
            <a:stretch/>
          </p:blipFill>
          <p:spPr>
            <a:xfrm>
              <a:off x="1531620" y="3335025"/>
              <a:ext cx="5770517" cy="4450438"/>
            </a:xfrm>
            <a:prstGeom prst="rect">
              <a:avLst/>
            </a:prstGeom>
          </p:spPr>
        </p:pic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879ED331-B7B5-5C4E-9969-B66E709F8D43}"/>
                </a:ext>
              </a:extLst>
            </p:cNvPr>
            <p:cNvSpPr txBox="1"/>
            <p:nvPr/>
          </p:nvSpPr>
          <p:spPr>
            <a:xfrm>
              <a:off x="1990067" y="4761382"/>
              <a:ext cx="4632802" cy="52322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sz="2800" dirty="0"/>
            </a:p>
          </p:txBody>
        </p:sp>
      </p:grpSp>
      <p:sp>
        <p:nvSpPr>
          <p:cNvPr id="76" name="文本框 75">
            <a:extLst>
              <a:ext uri="{FF2B5EF4-FFF2-40B4-BE49-F238E27FC236}">
                <a16:creationId xmlns:a16="http://schemas.microsoft.com/office/drawing/2014/main" id="{3CFDE883-7430-CF48-9CF1-9DA573DE8473}"/>
              </a:ext>
            </a:extLst>
          </p:cNvPr>
          <p:cNvSpPr txBox="1"/>
          <p:nvPr/>
        </p:nvSpPr>
        <p:spPr>
          <a:xfrm>
            <a:off x="5098079" y="6262271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RIP3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00CA79C6-6676-4E45-95F7-C6379221A936}"/>
              </a:ext>
            </a:extLst>
          </p:cNvPr>
          <p:cNvGrpSpPr/>
          <p:nvPr/>
        </p:nvGrpSpPr>
        <p:grpSpPr>
          <a:xfrm>
            <a:off x="859186" y="7814537"/>
            <a:ext cx="1512031" cy="1170601"/>
            <a:chOff x="0" y="5391144"/>
            <a:chExt cx="4926008" cy="3291817"/>
          </a:xfrm>
        </p:grpSpPr>
        <p:pic>
          <p:nvPicPr>
            <p:cNvPr id="77" name="图片 76">
              <a:extLst>
                <a:ext uri="{FF2B5EF4-FFF2-40B4-BE49-F238E27FC236}">
                  <a16:creationId xmlns:a16="http://schemas.microsoft.com/office/drawing/2014/main" id="{8E0CE2A6-1AF3-874D-9BEE-9A631A39E0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9909" t="19383" r="19482" b="21993"/>
            <a:stretch/>
          </p:blipFill>
          <p:spPr>
            <a:xfrm>
              <a:off x="0" y="5391144"/>
              <a:ext cx="4926008" cy="3291817"/>
            </a:xfrm>
            <a:prstGeom prst="rect">
              <a:avLst/>
            </a:prstGeom>
          </p:spPr>
        </p:pic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4C62C8B8-01E5-2C4C-9414-182A6A732870}"/>
                </a:ext>
              </a:extLst>
            </p:cNvPr>
            <p:cNvSpPr txBox="1"/>
            <p:nvPr/>
          </p:nvSpPr>
          <p:spPr>
            <a:xfrm>
              <a:off x="375249" y="6432538"/>
              <a:ext cx="3941659" cy="46166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sz="2400" dirty="0"/>
            </a:p>
          </p:txBody>
        </p:sp>
      </p:grpSp>
      <p:sp>
        <p:nvSpPr>
          <p:cNvPr id="80" name="文本框 79">
            <a:extLst>
              <a:ext uri="{FF2B5EF4-FFF2-40B4-BE49-F238E27FC236}">
                <a16:creationId xmlns:a16="http://schemas.microsoft.com/office/drawing/2014/main" id="{B5403E84-887B-EF4E-AE3F-F412FB3876D8}"/>
              </a:ext>
            </a:extLst>
          </p:cNvPr>
          <p:cNvSpPr txBox="1"/>
          <p:nvPr/>
        </p:nvSpPr>
        <p:spPr>
          <a:xfrm>
            <a:off x="1312073" y="7852046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571B313D-97A3-2B47-BF11-50C019F98B4F}"/>
              </a:ext>
            </a:extLst>
          </p:cNvPr>
          <p:cNvGrpSpPr/>
          <p:nvPr/>
        </p:nvGrpSpPr>
        <p:grpSpPr>
          <a:xfrm>
            <a:off x="2646806" y="7796416"/>
            <a:ext cx="1725616" cy="1170601"/>
            <a:chOff x="0" y="3671659"/>
            <a:chExt cx="6740434" cy="4722321"/>
          </a:xfrm>
        </p:grpSpPr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36793614-218A-F74B-9AF8-6C7796D1AA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15103" t="13832" r="12184" b="22876"/>
            <a:stretch/>
          </p:blipFill>
          <p:spPr>
            <a:xfrm>
              <a:off x="0" y="3671659"/>
              <a:ext cx="6740434" cy="4722321"/>
            </a:xfrm>
            <a:prstGeom prst="rect">
              <a:avLst/>
            </a:prstGeom>
          </p:spPr>
        </p:pic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C4126729-BDE9-484B-8DBC-A0516567F09C}"/>
                </a:ext>
              </a:extLst>
            </p:cNvPr>
            <p:cNvSpPr txBox="1"/>
            <p:nvPr/>
          </p:nvSpPr>
          <p:spPr>
            <a:xfrm>
              <a:off x="520169" y="5386344"/>
              <a:ext cx="5125170" cy="46166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sz="2400" dirty="0"/>
            </a:p>
          </p:txBody>
        </p:sp>
      </p:grpSp>
      <p:sp>
        <p:nvSpPr>
          <p:cNvPr id="84" name="文本框 83">
            <a:extLst>
              <a:ext uri="{FF2B5EF4-FFF2-40B4-BE49-F238E27FC236}">
                <a16:creationId xmlns:a16="http://schemas.microsoft.com/office/drawing/2014/main" id="{4036234F-2B17-E840-8F64-AFC270C1EC28}"/>
              </a:ext>
            </a:extLst>
          </p:cNvPr>
          <p:cNvSpPr txBox="1"/>
          <p:nvPr/>
        </p:nvSpPr>
        <p:spPr>
          <a:xfrm>
            <a:off x="3103386" y="7858965"/>
            <a:ext cx="902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MLKL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E87B5840-AB11-9140-9253-EC46334AD1C7}"/>
              </a:ext>
            </a:extLst>
          </p:cNvPr>
          <p:cNvGrpSpPr/>
          <p:nvPr/>
        </p:nvGrpSpPr>
        <p:grpSpPr>
          <a:xfrm>
            <a:off x="4632081" y="7903648"/>
            <a:ext cx="1786351" cy="1039062"/>
            <a:chOff x="-274320" y="4331653"/>
            <a:chExt cx="3519925" cy="2393680"/>
          </a:xfrm>
        </p:grpSpPr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D6EAACF3-710B-B848-839B-88DE8A9ACF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13814" t="18886" r="18509" b="23933"/>
            <a:stretch/>
          </p:blipFill>
          <p:spPr>
            <a:xfrm>
              <a:off x="-274320" y="4331653"/>
              <a:ext cx="3519925" cy="2393680"/>
            </a:xfrm>
            <a:prstGeom prst="rect">
              <a:avLst/>
            </a:prstGeom>
          </p:spPr>
        </p:pic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56441C6E-0D4D-F44C-B32B-8423CF4F4BAC}"/>
                </a:ext>
              </a:extLst>
            </p:cNvPr>
            <p:cNvSpPr txBox="1"/>
            <p:nvPr/>
          </p:nvSpPr>
          <p:spPr>
            <a:xfrm>
              <a:off x="-29649" y="5395573"/>
              <a:ext cx="3016578" cy="36933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dirty="0"/>
            </a:p>
          </p:txBody>
        </p:sp>
      </p:grpSp>
      <p:sp>
        <p:nvSpPr>
          <p:cNvPr id="88" name="文本框 87">
            <a:extLst>
              <a:ext uri="{FF2B5EF4-FFF2-40B4-BE49-F238E27FC236}">
                <a16:creationId xmlns:a16="http://schemas.microsoft.com/office/drawing/2014/main" id="{1FB34AB6-D05F-4640-A25A-706E18B0F581}"/>
              </a:ext>
            </a:extLst>
          </p:cNvPr>
          <p:cNvSpPr txBox="1"/>
          <p:nvPr/>
        </p:nvSpPr>
        <p:spPr>
          <a:xfrm>
            <a:off x="1564283" y="9020879"/>
            <a:ext cx="43662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effectLst/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Full western blot images related to Figure 6E</a:t>
            </a:r>
            <a:r>
              <a:rPr lang="zh-CN" altLang="zh-CN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1549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41</Words>
  <Application>Microsoft Macintosh PowerPoint</Application>
  <PresentationFormat>A4 纸张(210x297 毫米)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vvvvvviliant@gmail.com</dc:creator>
  <cp:lastModifiedBy>vvvvvviliant@gmail.com</cp:lastModifiedBy>
  <cp:revision>1</cp:revision>
  <dcterms:created xsi:type="dcterms:W3CDTF">2024-06-21T05:58:46Z</dcterms:created>
  <dcterms:modified xsi:type="dcterms:W3CDTF">2024-06-21T07:08:11Z</dcterms:modified>
</cp:coreProperties>
</file>